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>
        <p:scale>
          <a:sx n="110" d="100"/>
          <a:sy n="110" d="100"/>
        </p:scale>
        <p:origin x="605" y="-197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C:\Users\DS\AppData\Local\Microsoft\Windows\Temporary%20Internet%20Files\Content.IE5\B47CMNXC\170329~%20SK-Hep-1%20&#51333;&#50577;&#52769;&#51221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3639239373678048"/>
          <c:y val="6.4043484951054844E-2"/>
          <c:w val="0.71505691744201294"/>
          <c:h val="0.70885209377089009"/>
        </c:manualLayout>
      </c:layout>
      <c:scatterChart>
        <c:scatterStyle val="lineMarker"/>
        <c:varyColors val="0"/>
        <c:ser>
          <c:idx val="0"/>
          <c:order val="0"/>
          <c:tx>
            <c:strRef>
              <c:f>'[170329~ SK-Hep-1 종양측정.xlsx]SNU-387 그래프'!$B$3</c:f>
              <c:strCache>
                <c:ptCount val="1"/>
                <c:pt idx="0">
                  <c:v>Male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  <a:effectLst/>
            </c:spPr>
          </c:marker>
          <c:dLbls>
            <c:delete val="1"/>
          </c:dLbls>
          <c:errBars>
            <c:errDir val="y"/>
            <c:errBarType val="plus"/>
            <c:errValType val="cust"/>
            <c:noEndCap val="0"/>
            <c:plus>
              <c:numRef>
                <c:f>'[170329~ SK-Hep-1 종양측정.xlsx]SNU-387 그래프'!$K$5:$K$20</c:f>
                <c:numCache>
                  <c:formatCode>General</c:formatCode>
                  <c:ptCount val="16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88.942884037916556</c:v>
                  </c:pt>
                  <c:pt idx="4">
                    <c:v>87.229714657948875</c:v>
                  </c:pt>
                  <c:pt idx="5">
                    <c:v>87.229714657948875</c:v>
                  </c:pt>
                  <c:pt idx="6">
                    <c:v>107.1477597919036</c:v>
                  </c:pt>
                  <c:pt idx="7">
                    <c:v>131.64106314562375</c:v>
                  </c:pt>
                  <c:pt idx="8">
                    <c:v>118.3295864688299</c:v>
                  </c:pt>
                  <c:pt idx="9">
                    <c:v>115.21217367867368</c:v>
                  </c:pt>
                  <c:pt idx="10">
                    <c:v>126.64469725210479</c:v>
                  </c:pt>
                  <c:pt idx="11">
                    <c:v>143.4450688056672</c:v>
                  </c:pt>
                  <c:pt idx="12">
                    <c:v>164.52570253953797</c:v>
                  </c:pt>
                  <c:pt idx="13">
                    <c:v>163.18981701899864</c:v>
                  </c:pt>
                  <c:pt idx="14">
                    <c:v>169.2626512827145</c:v>
                  </c:pt>
                  <c:pt idx="15">
                    <c:v>123.2432427415989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[170329~ SK-Hep-1 종양측정.xlsx]SNU-387 그래프'!$D$5:$D$20</c:f>
              <c:numCache>
                <c:formatCode>General</c:formatCode>
                <c:ptCount val="16"/>
                <c:pt idx="0">
                  <c:v>0</c:v>
                </c:pt>
                <c:pt idx="1">
                  <c:v>2</c:v>
                </c:pt>
                <c:pt idx="2">
                  <c:v>5</c:v>
                </c:pt>
                <c:pt idx="3">
                  <c:v>7</c:v>
                </c:pt>
                <c:pt idx="4">
                  <c:v>9</c:v>
                </c:pt>
                <c:pt idx="5">
                  <c:v>12</c:v>
                </c:pt>
                <c:pt idx="6" formatCode="0_);[Red]\(0\)">
                  <c:v>14</c:v>
                </c:pt>
                <c:pt idx="7" formatCode="0_);[Red]\(0\)">
                  <c:v>16</c:v>
                </c:pt>
                <c:pt idx="8" formatCode="0_);[Red]\(0\)">
                  <c:v>19</c:v>
                </c:pt>
                <c:pt idx="9" formatCode="0_);[Red]\(0\)">
                  <c:v>21</c:v>
                </c:pt>
                <c:pt idx="10">
                  <c:v>23</c:v>
                </c:pt>
                <c:pt idx="11">
                  <c:v>26</c:v>
                </c:pt>
                <c:pt idx="12">
                  <c:v>28</c:v>
                </c:pt>
                <c:pt idx="13">
                  <c:v>30</c:v>
                </c:pt>
                <c:pt idx="14">
                  <c:v>33</c:v>
                </c:pt>
                <c:pt idx="15">
                  <c:v>35</c:v>
                </c:pt>
              </c:numCache>
            </c:numRef>
          </c:xVal>
          <c:yVal>
            <c:numRef>
              <c:f>'[170329~ SK-Hep-1 종양측정.xlsx]SNU-387 그래프'!$J$5:$J$20</c:f>
              <c:numCache>
                <c:formatCode>0.00_);[Red]\(0.0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35.81739833333333</c:v>
                </c:pt>
                <c:pt idx="4">
                  <c:v>151.88046787499999</c:v>
                </c:pt>
                <c:pt idx="5">
                  <c:v>151.88046787499999</c:v>
                </c:pt>
                <c:pt idx="6">
                  <c:v>193.18252637500001</c:v>
                </c:pt>
                <c:pt idx="7">
                  <c:v>226.95364687499998</c:v>
                </c:pt>
                <c:pt idx="8">
                  <c:v>216.45893437500001</c:v>
                </c:pt>
                <c:pt idx="9">
                  <c:v>259.564161125</c:v>
                </c:pt>
                <c:pt idx="10">
                  <c:v>249.5125615</c:v>
                </c:pt>
                <c:pt idx="11">
                  <c:v>310.35446925000002</c:v>
                </c:pt>
                <c:pt idx="12">
                  <c:v>316.07581349999998</c:v>
                </c:pt>
                <c:pt idx="13">
                  <c:v>326.30259612499998</c:v>
                </c:pt>
                <c:pt idx="14">
                  <c:v>358.66338775000003</c:v>
                </c:pt>
                <c:pt idx="15">
                  <c:v>408.973764499999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70E-4EB6-B4F5-D3F7CC0EA212}"/>
            </c:ext>
          </c:extLst>
        </c:ser>
        <c:ser>
          <c:idx val="1"/>
          <c:order val="1"/>
          <c:tx>
            <c:strRef>
              <c:f>'[170329~ SK-Hep-1 종양측정.xlsx]SNU-387 그래프'!$B$24</c:f>
              <c:strCache>
                <c:ptCount val="1"/>
                <c:pt idx="0">
                  <c:v>Female</c:v>
                </c:pt>
              </c:strCache>
            </c:strRef>
          </c:tx>
          <c:spPr>
            <a:ln w="22225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7"/>
            <c:spPr>
              <a:solidFill>
                <a:sysClr val="windowText" lastClr="000000"/>
              </a:solidFill>
              <a:ln w="6350">
                <a:solidFill>
                  <a:sysClr val="windowText" lastClr="000000"/>
                </a:solidFill>
              </a:ln>
              <a:effectLst/>
            </c:spPr>
          </c:marker>
          <c:dLbls>
            <c:delete val="1"/>
          </c:dLbls>
          <c:errBars>
            <c:errDir val="y"/>
            <c:errBarType val="plus"/>
            <c:errValType val="cust"/>
            <c:noEndCap val="0"/>
            <c:plus>
              <c:numRef>
                <c:f>'[170329~ SK-Hep-1 종양측정.xlsx]SNU-387 그래프'!$K$26:$K$41</c:f>
                <c:numCache>
                  <c:formatCode>General</c:formatCode>
                  <c:ptCount val="16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53.144557983074463</c:v>
                  </c:pt>
                  <c:pt idx="4">
                    <c:v>48.894460675402804</c:v>
                  </c:pt>
                  <c:pt idx="5">
                    <c:v>54.276960653068627</c:v>
                  </c:pt>
                  <c:pt idx="6">
                    <c:v>59.808002560102963</c:v>
                  </c:pt>
                  <c:pt idx="7">
                    <c:v>66.482438674352153</c:v>
                  </c:pt>
                  <c:pt idx="8">
                    <c:v>81.703439486240768</c:v>
                  </c:pt>
                  <c:pt idx="9">
                    <c:v>79.389916792865336</c:v>
                  </c:pt>
                  <c:pt idx="10">
                    <c:v>77.986428518203894</c:v>
                  </c:pt>
                  <c:pt idx="11">
                    <c:v>85.614496740313513</c:v>
                  </c:pt>
                  <c:pt idx="12">
                    <c:v>77.016934843415896</c:v>
                  </c:pt>
                  <c:pt idx="13">
                    <c:v>63.944621212053413</c:v>
                  </c:pt>
                  <c:pt idx="14">
                    <c:v>66.052037137319985</c:v>
                  </c:pt>
                  <c:pt idx="15">
                    <c:v>100.564661201623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'[170329~ SK-Hep-1 종양측정.xlsx]SNU-387 그래프'!$D$26:$D$41</c:f>
              <c:numCache>
                <c:formatCode>General</c:formatCode>
                <c:ptCount val="16"/>
                <c:pt idx="0">
                  <c:v>0</c:v>
                </c:pt>
                <c:pt idx="1">
                  <c:v>2</c:v>
                </c:pt>
                <c:pt idx="2">
                  <c:v>5</c:v>
                </c:pt>
                <c:pt idx="3">
                  <c:v>7</c:v>
                </c:pt>
                <c:pt idx="4">
                  <c:v>9</c:v>
                </c:pt>
                <c:pt idx="5">
                  <c:v>12</c:v>
                </c:pt>
                <c:pt idx="6" formatCode="0_);[Red]\(0\)">
                  <c:v>14</c:v>
                </c:pt>
                <c:pt idx="7" formatCode="0_);[Red]\(0\)">
                  <c:v>16</c:v>
                </c:pt>
                <c:pt idx="8" formatCode="0_);[Red]\(0\)">
                  <c:v>19</c:v>
                </c:pt>
                <c:pt idx="9" formatCode="0_);[Red]\(0\)">
                  <c:v>21</c:v>
                </c:pt>
                <c:pt idx="10">
                  <c:v>23</c:v>
                </c:pt>
                <c:pt idx="11">
                  <c:v>26</c:v>
                </c:pt>
                <c:pt idx="12">
                  <c:v>28</c:v>
                </c:pt>
                <c:pt idx="13">
                  <c:v>30</c:v>
                </c:pt>
                <c:pt idx="14">
                  <c:v>33</c:v>
                </c:pt>
                <c:pt idx="15">
                  <c:v>35</c:v>
                </c:pt>
              </c:numCache>
            </c:numRef>
          </c:xVal>
          <c:yVal>
            <c:numRef>
              <c:f>'[170329~ SK-Hep-1 종양측정.xlsx]SNU-387 그래프'!$J$26:$J$41</c:f>
              <c:numCache>
                <c:formatCode>0.00_);[Red]\(0.0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89.034295499999999</c:v>
                </c:pt>
                <c:pt idx="4">
                  <c:v>69.712277799999995</c:v>
                </c:pt>
                <c:pt idx="5">
                  <c:v>75.197147300000012</c:v>
                </c:pt>
                <c:pt idx="6">
                  <c:v>95.547198100000003</c:v>
                </c:pt>
                <c:pt idx="7">
                  <c:v>115.8592343</c:v>
                </c:pt>
                <c:pt idx="8">
                  <c:v>136.44303070000001</c:v>
                </c:pt>
                <c:pt idx="9">
                  <c:v>127.81794029999999</c:v>
                </c:pt>
                <c:pt idx="10">
                  <c:v>143.17584159999998</c:v>
                </c:pt>
                <c:pt idx="11">
                  <c:v>131.6715466</c:v>
                </c:pt>
                <c:pt idx="12">
                  <c:v>144.11119860000002</c:v>
                </c:pt>
                <c:pt idx="13">
                  <c:v>137.20778910000001</c:v>
                </c:pt>
                <c:pt idx="14">
                  <c:v>143.10163160000005</c:v>
                </c:pt>
                <c:pt idx="15">
                  <c:v>185.921405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70E-4EB6-B4F5-D3F7CC0EA212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axId val="1587436048"/>
        <c:axId val="1587432784"/>
      </c:scatterChart>
      <c:valAx>
        <c:axId val="1587436048"/>
        <c:scaling>
          <c:orientation val="minMax"/>
          <c:max val="4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5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ko-KR" sz="1050" b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ys</a:t>
                </a:r>
                <a:endParaRPr lang="ko-KR" altLang="en-US" sz="1050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5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1587432784"/>
        <c:crosses val="autoZero"/>
        <c:crossBetween val="midCat"/>
        <c:majorUnit val="5"/>
      </c:valAx>
      <c:valAx>
        <c:axId val="158743278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ko-KR" sz="1050" b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umor</a:t>
                </a:r>
                <a:r>
                  <a:rPr lang="en-US" altLang="ko-KR" sz="1050" b="1" baseline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volume (mm3)</a:t>
                </a:r>
                <a:endParaRPr lang="ko-KR" altLang="en-US" sz="1050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1.8943051879323776E-2"/>
              <c:y val="9.8650357407943576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#,##0_);[Red]\(#,##0\)" sourceLinked="0"/>
        <c:majorTickMark val="cross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1587436048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504752820308096"/>
          <c:y val="6.1078332172564698E-2"/>
          <c:w val="0.26643300444662982"/>
          <c:h val="0.1803660681395923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ko-K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71568C-465F-43AB-AC36-E9E0B188C728}" type="datetimeFigureOut">
              <a:rPr lang="ko-KR" altLang="en-US" smtClean="0"/>
              <a:t>2020-11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A8D33B-AB4A-487C-91BC-7E30258A94F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200691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71568C-465F-43AB-AC36-E9E0B188C728}" type="datetimeFigureOut">
              <a:rPr lang="ko-KR" altLang="en-US" smtClean="0"/>
              <a:t>2020-11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A8D33B-AB4A-487C-91BC-7E30258A94F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688708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71568C-465F-43AB-AC36-E9E0B188C728}" type="datetimeFigureOut">
              <a:rPr lang="ko-KR" altLang="en-US" smtClean="0"/>
              <a:t>2020-11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A8D33B-AB4A-487C-91BC-7E30258A94F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96909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71568C-465F-43AB-AC36-E9E0B188C728}" type="datetimeFigureOut">
              <a:rPr lang="ko-KR" altLang="en-US" smtClean="0"/>
              <a:t>2020-11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A8D33B-AB4A-487C-91BC-7E30258A94F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318370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71568C-465F-43AB-AC36-E9E0B188C728}" type="datetimeFigureOut">
              <a:rPr lang="ko-KR" altLang="en-US" smtClean="0"/>
              <a:t>2020-11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A8D33B-AB4A-487C-91BC-7E30258A94F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151920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71568C-465F-43AB-AC36-E9E0B188C728}" type="datetimeFigureOut">
              <a:rPr lang="ko-KR" altLang="en-US" smtClean="0"/>
              <a:t>2020-11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A8D33B-AB4A-487C-91BC-7E30258A94F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603224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71568C-465F-43AB-AC36-E9E0B188C728}" type="datetimeFigureOut">
              <a:rPr lang="ko-KR" altLang="en-US" smtClean="0"/>
              <a:t>2020-11-2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A8D33B-AB4A-487C-91BC-7E30258A94F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545447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71568C-465F-43AB-AC36-E9E0B188C728}" type="datetimeFigureOut">
              <a:rPr lang="ko-KR" altLang="en-US" smtClean="0"/>
              <a:t>2020-11-2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A8D33B-AB4A-487C-91BC-7E30258A94F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640861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71568C-465F-43AB-AC36-E9E0B188C728}" type="datetimeFigureOut">
              <a:rPr lang="ko-KR" altLang="en-US" smtClean="0"/>
              <a:t>2020-11-2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A8D33B-AB4A-487C-91BC-7E30258A94F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986552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71568C-465F-43AB-AC36-E9E0B188C728}" type="datetimeFigureOut">
              <a:rPr lang="ko-KR" altLang="en-US" smtClean="0"/>
              <a:t>2020-11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A8D33B-AB4A-487C-91BC-7E30258A94F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681049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71568C-465F-43AB-AC36-E9E0B188C728}" type="datetimeFigureOut">
              <a:rPr lang="ko-KR" altLang="en-US" smtClean="0"/>
              <a:t>2020-11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A8D33B-AB4A-487C-91BC-7E30258A94F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923527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71568C-465F-43AB-AC36-E9E0B188C728}" type="datetimeFigureOut">
              <a:rPr lang="ko-KR" altLang="en-US" smtClean="0"/>
              <a:t>2020-11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A8D33B-AB4A-487C-91BC-7E30258A94F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338661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그룹 13">
            <a:extLst>
              <a:ext uri="{FF2B5EF4-FFF2-40B4-BE49-F238E27FC236}">
                <a16:creationId xmlns:a16="http://schemas.microsoft.com/office/drawing/2014/main" id="{816672A7-72B2-4F8B-BE1E-5412E5BA2BEC}"/>
              </a:ext>
            </a:extLst>
          </p:cNvPr>
          <p:cNvGrpSpPr/>
          <p:nvPr/>
        </p:nvGrpSpPr>
        <p:grpSpPr>
          <a:xfrm>
            <a:off x="785527" y="2899255"/>
            <a:ext cx="2933635" cy="2359069"/>
            <a:chOff x="189781" y="2816128"/>
            <a:chExt cx="2933635" cy="2359069"/>
          </a:xfrm>
        </p:grpSpPr>
        <p:graphicFrame>
          <p:nvGraphicFramePr>
            <p:cNvPr id="5" name="차트 4">
              <a:extLst>
                <a:ext uri="{FF2B5EF4-FFF2-40B4-BE49-F238E27FC236}">
                  <a16:creationId xmlns:a16="http://schemas.microsoft.com/office/drawing/2014/main" id="{782CFD43-87DC-43A3-B485-7B659851B76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201465660"/>
                </p:ext>
              </p:extLst>
            </p:nvPr>
          </p:nvGraphicFramePr>
          <p:xfrm>
            <a:off x="189781" y="2816128"/>
            <a:ext cx="2933635" cy="235906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6" name="TextBox 3">
              <a:extLst>
                <a:ext uri="{FF2B5EF4-FFF2-40B4-BE49-F238E27FC236}">
                  <a16:creationId xmlns:a16="http://schemas.microsoft.com/office/drawing/2014/main" id="{44FBC07F-E6E9-482D-84F1-67E169A0CFC5}"/>
                </a:ext>
              </a:extLst>
            </p:cNvPr>
            <p:cNvSpPr txBox="1"/>
            <p:nvPr/>
          </p:nvSpPr>
          <p:spPr>
            <a:xfrm>
              <a:off x="2370147" y="3492459"/>
              <a:ext cx="371475" cy="212725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eaLnBrk="1" fontAlgn="auto" latinLnBrk="1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ko-KR" sz="1200" dirty="0">
                  <a:solidFill>
                    <a:prstClr val="black"/>
                  </a:solidFill>
                </a:rPr>
                <a:t>*</a:t>
              </a:r>
              <a:endParaRPr lang="ko-KR" altLang="en-US" sz="900" dirty="0">
                <a:solidFill>
                  <a:prstClr val="black"/>
                </a:solidFill>
              </a:endParaRPr>
            </a:p>
          </p:txBody>
        </p:sp>
        <p:sp>
          <p:nvSpPr>
            <p:cNvPr id="7" name="TextBox 4">
              <a:extLst>
                <a:ext uri="{FF2B5EF4-FFF2-40B4-BE49-F238E27FC236}">
                  <a16:creationId xmlns:a16="http://schemas.microsoft.com/office/drawing/2014/main" id="{B71C14E0-A4AB-4C9A-B0BC-4273AFA00642}"/>
                </a:ext>
              </a:extLst>
            </p:cNvPr>
            <p:cNvSpPr txBox="1"/>
            <p:nvPr/>
          </p:nvSpPr>
          <p:spPr>
            <a:xfrm>
              <a:off x="2660508" y="3297552"/>
              <a:ext cx="117475" cy="125413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eaLnBrk="1" fontAlgn="auto" latinLnBrk="1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ko-KR" sz="1200" dirty="0">
                  <a:solidFill>
                    <a:prstClr val="black"/>
                  </a:solidFill>
                </a:rPr>
                <a:t>*</a:t>
              </a:r>
              <a:endParaRPr lang="ko-KR" altLang="en-US" sz="900" dirty="0">
                <a:solidFill>
                  <a:prstClr val="black"/>
                </a:solidFill>
              </a:endParaRPr>
            </a:p>
          </p:txBody>
        </p:sp>
        <p:sp>
          <p:nvSpPr>
            <p:cNvPr id="8" name="TextBox 5">
              <a:extLst>
                <a:ext uri="{FF2B5EF4-FFF2-40B4-BE49-F238E27FC236}">
                  <a16:creationId xmlns:a16="http://schemas.microsoft.com/office/drawing/2014/main" id="{CC3CB9C9-835F-4AD8-9282-2CC13571F940}"/>
                </a:ext>
              </a:extLst>
            </p:cNvPr>
            <p:cNvSpPr txBox="1"/>
            <p:nvPr/>
          </p:nvSpPr>
          <p:spPr>
            <a:xfrm>
              <a:off x="2286221" y="3533322"/>
              <a:ext cx="112713" cy="130175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eaLnBrk="1" fontAlgn="auto" latinLnBrk="1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ko-KR" sz="1200" dirty="0">
                  <a:solidFill>
                    <a:prstClr val="black"/>
                  </a:solidFill>
                </a:rPr>
                <a:t>*</a:t>
              </a:r>
              <a:endParaRPr lang="ko-KR" altLang="en-US" sz="900" dirty="0">
                <a:solidFill>
                  <a:prstClr val="black"/>
                </a:solidFill>
              </a:endParaRPr>
            </a:p>
          </p:txBody>
        </p:sp>
        <p:sp>
          <p:nvSpPr>
            <p:cNvPr id="9" name="TextBox 6">
              <a:extLst>
                <a:ext uri="{FF2B5EF4-FFF2-40B4-BE49-F238E27FC236}">
                  <a16:creationId xmlns:a16="http://schemas.microsoft.com/office/drawing/2014/main" id="{716C1F4B-AA83-4CBF-A0E0-BDFDF8EBCB67}"/>
                </a:ext>
              </a:extLst>
            </p:cNvPr>
            <p:cNvSpPr txBox="1"/>
            <p:nvPr/>
          </p:nvSpPr>
          <p:spPr>
            <a:xfrm>
              <a:off x="2180982" y="3574596"/>
              <a:ext cx="111125" cy="130175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eaLnBrk="1" fontAlgn="auto" latinLnBrk="1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ko-KR" sz="1200" dirty="0">
                  <a:solidFill>
                    <a:prstClr val="black"/>
                  </a:solidFill>
                </a:rPr>
                <a:t>*</a:t>
              </a:r>
              <a:endParaRPr lang="ko-KR" altLang="en-US" sz="900" dirty="0">
                <a:solidFill>
                  <a:prstClr val="black"/>
                </a:solidFill>
              </a:endParaRPr>
            </a:p>
          </p:txBody>
        </p:sp>
        <p:sp>
          <p:nvSpPr>
            <p:cNvPr id="12" name="TextBox 17">
              <a:extLst>
                <a:ext uri="{FF2B5EF4-FFF2-40B4-BE49-F238E27FC236}">
                  <a16:creationId xmlns:a16="http://schemas.microsoft.com/office/drawing/2014/main" id="{80FC713E-283F-4B3F-B0D7-9DBECF1BB45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01307" y="2879112"/>
              <a:ext cx="971550" cy="52546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750"/>
                </a:spcBef>
                <a:buFont typeface="Wingdings 2" panose="05020102010507070707" pitchFamily="18" charset="2"/>
                <a:buChar char=""/>
                <a:defRPr sz="21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375"/>
                </a:spcBef>
                <a:buFont typeface="Wingdings 2" panose="05020102010507070707" pitchFamily="18" charset="2"/>
                <a:buChar char="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375"/>
                </a:spcBef>
                <a:buFont typeface="Wingdings 2" panose="05020102010507070707" pitchFamily="18" charset="2"/>
                <a:buChar char=""/>
                <a:defRPr sz="15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375"/>
                </a:spcBef>
                <a:buFont typeface="Wingdings 2" panose="05020102010507070707" pitchFamily="18" charset="2"/>
                <a:buChar char=""/>
                <a:defRPr sz="13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375"/>
                </a:spcBef>
                <a:buFont typeface="Wingdings 2" panose="05020102010507070707" pitchFamily="18" charset="2"/>
                <a:buChar char=""/>
                <a:defRPr sz="13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Wingdings 2" panose="05020102010507070707" pitchFamily="18" charset="2"/>
                <a:buChar char=""/>
                <a:defRPr sz="13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Wingdings 2" panose="05020102010507070707" pitchFamily="18" charset="2"/>
                <a:buChar char=""/>
                <a:defRPr sz="13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Wingdings 2" panose="05020102010507070707" pitchFamily="18" charset="2"/>
                <a:buChar char=""/>
                <a:defRPr sz="13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Wingdings 2" panose="05020102010507070707" pitchFamily="18" charset="2"/>
                <a:buChar char=""/>
                <a:defRPr sz="13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5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le Mice</a:t>
              </a:r>
            </a:p>
            <a:p>
              <a:pPr eaLnBrk="1" hangingPunct="1">
                <a:lnSpc>
                  <a:spcPct val="15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emale Mice</a:t>
              </a:r>
              <a:endParaRPr lang="ko-KR" alt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3">
              <a:extLst>
                <a:ext uri="{FF2B5EF4-FFF2-40B4-BE49-F238E27FC236}">
                  <a16:creationId xmlns:a16="http://schemas.microsoft.com/office/drawing/2014/main" id="{9535936A-82C9-42A7-948D-AC6C1A6F6FAD}"/>
                </a:ext>
              </a:extLst>
            </p:cNvPr>
            <p:cNvSpPr txBox="1"/>
            <p:nvPr/>
          </p:nvSpPr>
          <p:spPr>
            <a:xfrm>
              <a:off x="2518290" y="3402403"/>
              <a:ext cx="371475" cy="212725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eaLnBrk="1" fontAlgn="auto" latinLnBrk="1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ko-KR" sz="1200" dirty="0">
                  <a:solidFill>
                    <a:prstClr val="black"/>
                  </a:solidFill>
                </a:rPr>
                <a:t>*</a:t>
              </a:r>
              <a:endParaRPr lang="ko-KR" altLang="en-US" sz="900" dirty="0">
                <a:solidFill>
                  <a:prstClr val="black"/>
                </a:solidFill>
              </a:endParaRPr>
            </a:p>
          </p:txBody>
        </p:sp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id="{5593635E-2802-45E1-9127-F455684C19C0}"/>
              </a:ext>
            </a:extLst>
          </p:cNvPr>
          <p:cNvSpPr txBox="1"/>
          <p:nvPr/>
        </p:nvSpPr>
        <p:spPr>
          <a:xfrm>
            <a:off x="21405" y="7495309"/>
            <a:ext cx="6704648" cy="935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data 1. Sex difference in SK-Hep1-derived tumor growth</a:t>
            </a:r>
          </a:p>
          <a:p>
            <a:pPr>
              <a:lnSpc>
                <a:spcPct val="150000"/>
              </a:lnSpc>
            </a:pP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K-Hep1 cells (1×10</a:t>
            </a:r>
            <a:r>
              <a:rPr lang="en-US" altLang="ko-KR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cells/mouse) were subcutaneously injected into male and female BALB/c nude mice. Data are represented as the mean ± standard deviation (n=5). * 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&lt; 0.05 (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test).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615033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맑은 고딕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맑은 고딕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67000"/>
              <a:satMod val="105000"/>
              <a:lumMod val="110000"/>
            </a:schemeClr>
          </a:gs>
          <a:gs pos="50000">
            <a:schemeClr val="phClr">
              <a:tint val="73000"/>
              <a:satMod val="103000"/>
              <a:lumMod val="105000"/>
            </a:schemeClr>
          </a:gs>
          <a:gs pos="100000">
            <a:schemeClr val="phClr">
              <a:tint val="81000"/>
              <a:satMod val="109000"/>
              <a:lumMod val="105000"/>
            </a:schemeClr>
          </a:gs>
        </a:gsLst>
        <a:lin ang="5400000" scaled="0"/>
      </a:gradFill>
      <a:gradFill rotWithShape="1">
        <a:gsLst>
          <a:gs pos="0">
            <a:schemeClr val="phClr">
              <a:tint val="94000"/>
              <a:satMod val="103000"/>
              <a:lumMod val="102000"/>
            </a:schemeClr>
          </a:gs>
          <a:gs pos="50000">
            <a:schemeClr val="phClr">
              <a:shade val="100000"/>
              <a:satMod val="110000"/>
              <a:lumMod val="100000"/>
            </a:schemeClr>
          </a:gs>
          <a:gs pos="100000">
            <a:schemeClr val="phClr">
              <a:shade val="78000"/>
              <a:satMod val="120000"/>
              <a:lumMod val="99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</a:ln>
      <a:ln w="12700" cap="flat" cmpd="sng" algn="ctr">
        <a:solidFill>
          <a:schemeClr val="phClr"/>
        </a:solidFill>
        <a:prstDash val="solid"/>
      </a:ln>
      <a:ln w="19050" cap="flat" cmpd="sng" algn="ctr">
        <a:solidFill>
          <a:schemeClr val="phClr"/>
        </a:solidFill>
        <a:prstDash val="solid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hade val="98000"/>
              <a:satMod val="150000"/>
              <a:lumMod val="102000"/>
            </a:schemeClr>
          </a:gs>
          <a:gs pos="50000">
            <a:schemeClr val="phClr">
              <a:tint val="98000"/>
              <a:shade val="90000"/>
              <a:satMod val="13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</TotalTime>
  <Words>67</Words>
  <Application>Microsoft Office PowerPoint</Application>
  <PresentationFormat>A4 용지(210x297mm)</PresentationFormat>
  <Paragraphs>1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2008550@office.duksung.ac.kr</dc:creator>
  <cp:lastModifiedBy>2008550@office.duksung.ac.kr</cp:lastModifiedBy>
  <cp:revision>2</cp:revision>
  <dcterms:created xsi:type="dcterms:W3CDTF">2020-11-19T20:57:23Z</dcterms:created>
  <dcterms:modified xsi:type="dcterms:W3CDTF">2020-11-19T21:15:09Z</dcterms:modified>
</cp:coreProperties>
</file>